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36AF7-F5BD-4CAC-A174-15BAC1F3F0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7FB008-C9A6-4BD4-9B3A-A5E107A5BB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6919DA-B6A0-450E-854B-B59FC2658AA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4E9428-4736-497C-A5AF-C33F5C784B6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17CD185-9E47-4B7D-96AB-3038936848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6377CE2-FA67-4CDC-990C-E80279B8B5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9983F85-16DF-491E-8287-B9334B0A6A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5FF8C30-C1B7-44A6-BF41-52B46A9858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CE05775-C186-4773-A071-BF78D14B72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CD2E39A-E848-41FB-ADC8-5586D0A5A4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E9861A4-E632-4D9B-8E78-0F7290B9BB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7C918F-5C45-4592-9C82-84B5F05642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D5732AD-7586-40B5-91F5-588399AE9A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9024A33-A4EE-423D-A98D-079AD11CA2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16DC95F-31CB-4404-AED6-E01BE4FE29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37BC915-1D76-4E99-BF88-5A7A147C5F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8C62EB4-F303-435C-8EEA-7960E9AD40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D110EE-8FC9-4377-8C23-5741ACC1F9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F804E9-AED1-4E12-BE4E-7ED3802FB6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1DEC64-34E9-45DD-97CB-292A6BE610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D20678-8754-452E-9963-8177E60F7C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D1A0D-F73B-454E-8B76-BB49BCF833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628472-C31C-40A6-8E00-08EDB48982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73F185-6123-49F8-A95B-EAC209BAC1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1C90A0-5D7F-4D01-96FD-E559A3D5EEC6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2A1C38-0D84-431B-9F7F-78A25135E04D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2" name=""/>
          <p:cNvGraphicFramePr/>
          <p:nvPr/>
        </p:nvGraphicFramePr>
        <p:xfrm>
          <a:off x="1857240" y="863640"/>
          <a:ext cx="5297400" cy="5753160"/>
        </p:xfrm>
        <a:graphic>
          <a:graphicData uri="http://schemas.openxmlformats.org/drawingml/2006/table">
            <a:tbl>
              <a:tblPr/>
              <a:tblGrid>
                <a:gridCol w="588960"/>
                <a:gridCol w="588960"/>
                <a:gridCol w="587520"/>
                <a:gridCol w="588960"/>
                <a:gridCol w="588960"/>
                <a:gridCol w="588960"/>
                <a:gridCol w="588960"/>
                <a:gridCol w="587160"/>
                <a:gridCol w="588960"/>
              </a:tblGrid>
              <a:tr h="3110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nc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83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83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83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83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83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83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83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83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L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o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4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R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S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66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o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8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o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4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LB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S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B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66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NS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o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IC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IR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o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4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IR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o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M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o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4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H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U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4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US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o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S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o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4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A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o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P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o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o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4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R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C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o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G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o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4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Y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CE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4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C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V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3" name="PlaceHolder 1"/>
          <p:cNvSpPr>
            <a:spLocks noGrp="1"/>
          </p:cNvSpPr>
          <p:nvPr>
            <p:ph type="subTitle"/>
          </p:nvPr>
        </p:nvSpPr>
        <p:spPr>
          <a:xfrm>
            <a:off x="539640" y="188640"/>
            <a:ext cx="8229600" cy="67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Bef>
                <a:spcPts val="2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Supplementary Table S2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. Association between FAM83 family gene expression and patient prognosis across cancers (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</a:rPr>
              <a:t>p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 &lt; 0.05). "Poor" indicates that increased FAM83 family gene expression is associated with a poorer prognosis, while "good" indicates that increased FAM83 family gene expression is associated with a better prognosi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 type="subTitle"/>
          </p:nvPr>
        </p:nvSpPr>
        <p:spPr>
          <a:xfrm>
            <a:off x="539640" y="117000"/>
            <a:ext cx="8229600" cy="37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Table S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Distribution of staging in pan-cance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文本框 2"/>
          <p:cNvSpPr/>
          <p:nvPr/>
        </p:nvSpPr>
        <p:spPr>
          <a:xfrm>
            <a:off x="2730600" y="1533600"/>
            <a:ext cx="31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6" name=""/>
          <p:cNvGraphicFramePr/>
          <p:nvPr/>
        </p:nvGraphicFramePr>
        <p:xfrm>
          <a:off x="2384280" y="358920"/>
          <a:ext cx="4772160" cy="6433920"/>
        </p:xfrm>
        <a:graphic>
          <a:graphicData uri="http://schemas.openxmlformats.org/drawingml/2006/table">
            <a:tbl>
              <a:tblPr/>
              <a:tblGrid>
                <a:gridCol w="728640"/>
                <a:gridCol w="668520"/>
                <a:gridCol w="574560"/>
                <a:gridCol w="558720"/>
                <a:gridCol w="606600"/>
                <a:gridCol w="608040"/>
                <a:gridCol w="1027080"/>
              </a:tblGrid>
              <a:tr h="30204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GA I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umor Sampl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age 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age I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age II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age IV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t Reporte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L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R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ES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LB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S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B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NS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IC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IR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IR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AM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H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U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US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ES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V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A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CP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E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R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KC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Y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UCE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4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UC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UV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ot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3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9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subTitle"/>
          </p:nvPr>
        </p:nvSpPr>
        <p:spPr>
          <a:xfrm>
            <a:off x="539640" y="117000"/>
            <a:ext cx="822960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Table S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Distribution of immune subtypes in pan-canc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文本框 2"/>
          <p:cNvSpPr/>
          <p:nvPr/>
        </p:nvSpPr>
        <p:spPr>
          <a:xfrm>
            <a:off x="2730600" y="1533600"/>
            <a:ext cx="31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9" name=""/>
          <p:cNvGraphicFramePr/>
          <p:nvPr/>
        </p:nvGraphicFramePr>
        <p:xfrm>
          <a:off x="2235240" y="388800"/>
          <a:ext cx="4978440" cy="6434280"/>
        </p:xfrm>
        <a:graphic>
          <a:graphicData uri="http://schemas.openxmlformats.org/drawingml/2006/table">
            <a:tbl>
              <a:tblPr/>
              <a:tblGrid>
                <a:gridCol w="736560"/>
                <a:gridCol w="673200"/>
                <a:gridCol w="492120"/>
                <a:gridCol w="490320"/>
                <a:gridCol w="490680"/>
                <a:gridCol w="490680"/>
                <a:gridCol w="490320"/>
                <a:gridCol w="490680"/>
                <a:gridCol w="623880"/>
              </a:tblGrid>
              <a:tr h="30204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GA I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umor Sampl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t Reporte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L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R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ES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LB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S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B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NS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IC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IR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IR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AM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H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U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US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ES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V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A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CP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E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R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KC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A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Y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UCE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UC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UV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360"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ot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3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8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4-13T11:05:19Z</dcterms:created>
  <dc:creator>X</dc:creator>
  <dc:description/>
  <dc:language>en-US</dc:language>
  <cp:lastModifiedBy>太天真</cp:lastModifiedBy>
  <dcterms:modified xsi:type="dcterms:W3CDTF">2022-06-27T09:52:32Z</dcterms:modified>
  <cp:revision>5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1D70F26A79D4F6D9B6B8567355CBB8A</vt:lpwstr>
  </property>
  <property fmtid="{D5CDD505-2E9C-101B-9397-08002B2CF9AE}" pid="3" name="KSOProductBuildVer">
    <vt:lpwstr>2052-11.1.0.11830</vt:lpwstr>
  </property>
</Properties>
</file>